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48" d="100"/>
          <a:sy n="48" d="100"/>
        </p:scale>
        <p:origin x="-1434" y="-11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4BB850-A487-4578-9005-3E1646F8E604}" type="datetimeFigureOut">
              <a:rPr lang="en-US" smtClean="0"/>
              <a:pPr/>
              <a:t>3/1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A10DF-158C-4C92-AB57-0285D2C4D2D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4BB850-A487-4578-9005-3E1646F8E604}" type="datetimeFigureOut">
              <a:rPr lang="en-US" smtClean="0"/>
              <a:pPr/>
              <a:t>3/1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A10DF-158C-4C92-AB57-0285D2C4D2D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4BB850-A487-4578-9005-3E1646F8E604}" type="datetimeFigureOut">
              <a:rPr lang="en-US" smtClean="0"/>
              <a:pPr/>
              <a:t>3/1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A10DF-158C-4C92-AB57-0285D2C4D2D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4BB850-A487-4578-9005-3E1646F8E604}" type="datetimeFigureOut">
              <a:rPr lang="en-US" smtClean="0"/>
              <a:pPr/>
              <a:t>3/1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A10DF-158C-4C92-AB57-0285D2C4D2D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4BB850-A487-4578-9005-3E1646F8E604}" type="datetimeFigureOut">
              <a:rPr lang="en-US" smtClean="0"/>
              <a:pPr/>
              <a:t>3/1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A10DF-158C-4C92-AB57-0285D2C4D2D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4BB850-A487-4578-9005-3E1646F8E604}" type="datetimeFigureOut">
              <a:rPr lang="en-US" smtClean="0"/>
              <a:pPr/>
              <a:t>3/18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A10DF-158C-4C92-AB57-0285D2C4D2D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4BB850-A487-4578-9005-3E1646F8E604}" type="datetimeFigureOut">
              <a:rPr lang="en-US" smtClean="0"/>
              <a:pPr/>
              <a:t>3/18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A10DF-158C-4C92-AB57-0285D2C4D2D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4BB850-A487-4578-9005-3E1646F8E604}" type="datetimeFigureOut">
              <a:rPr lang="en-US" smtClean="0"/>
              <a:pPr/>
              <a:t>3/18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A10DF-158C-4C92-AB57-0285D2C4D2D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4BB850-A487-4578-9005-3E1646F8E604}" type="datetimeFigureOut">
              <a:rPr lang="en-US" smtClean="0"/>
              <a:pPr/>
              <a:t>3/18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A10DF-158C-4C92-AB57-0285D2C4D2D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4BB850-A487-4578-9005-3E1646F8E604}" type="datetimeFigureOut">
              <a:rPr lang="en-US" smtClean="0"/>
              <a:pPr/>
              <a:t>3/18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A10DF-158C-4C92-AB57-0285D2C4D2D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4BB850-A487-4578-9005-3E1646F8E604}" type="datetimeFigureOut">
              <a:rPr lang="en-US" smtClean="0"/>
              <a:pPr/>
              <a:t>3/18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A10DF-158C-4C92-AB57-0285D2C4D2D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4BB850-A487-4578-9005-3E1646F8E604}" type="datetimeFigureOut">
              <a:rPr lang="en-US" smtClean="0"/>
              <a:pPr/>
              <a:t>3/1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9A10DF-158C-4C92-AB57-0285D2C4D2D8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/>
        </p:nvGraphicFramePr>
        <p:xfrm>
          <a:off x="1600200" y="1676400"/>
          <a:ext cx="3657599" cy="26619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95400"/>
                <a:gridCol w="2362199"/>
              </a:tblGrid>
              <a:tr h="370840"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u="sng" dirty="0" smtClean="0">
                          <a:latin typeface="Times New Roman" pitchFamily="18" charset="0"/>
                          <a:cs typeface="Times New Roman" pitchFamily="18" charset="0"/>
                        </a:rPr>
                        <a:t>Supplemental Table S1</a:t>
                      </a:r>
                      <a:r>
                        <a:rPr lang="en-US" sz="1200" u="sng" dirty="0" smtClean="0">
                          <a:latin typeface="Times New Roman" pitchFamily="18" charset="0"/>
                          <a:cs typeface="Times New Roman" pitchFamily="18" charset="0"/>
                        </a:rPr>
                        <a:t>: Patient Demographics</a:t>
                      </a:r>
                      <a:endParaRPr lang="en-US" sz="1200" u="sng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Sex: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Male (62%)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</a:tr>
              <a:tr h="640080">
                <a:tc>
                  <a:txBody>
                    <a:bodyPr/>
                    <a:lstStyle/>
                    <a:p>
                      <a:pPr algn="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Age at </a:t>
                      </a:r>
                      <a:r>
                        <a:rPr lang="en-US" sz="12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Dx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Mean  19.5 yrs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Median 16</a:t>
                      </a:r>
                      <a:r>
                        <a:rPr lang="en-US" sz="1200" baseline="0" dirty="0" smtClean="0">
                          <a:latin typeface="Times New Roman" pitchFamily="18" charset="0"/>
                          <a:cs typeface="Times New Roman" pitchFamily="18" charset="0"/>
                        </a:rPr>
                        <a:t> yrs</a:t>
                      </a:r>
                      <a:endParaRPr lang="en-US" sz="1200" dirty="0" smtClean="0"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Range 3-51 years</a:t>
                      </a:r>
                    </a:p>
                  </a:txBody>
                  <a:tcPr anchor="ctr"/>
                </a:tc>
              </a:tr>
              <a:tr h="640080">
                <a:tc>
                  <a:txBody>
                    <a:bodyPr/>
                    <a:lstStyle/>
                    <a:p>
                      <a:pPr algn="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Stage at </a:t>
                      </a:r>
                      <a:r>
                        <a:rPr lang="en-US" sz="12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Dx</a:t>
                      </a:r>
                      <a:endParaRPr lang="en-US" sz="1200" dirty="0" smtClean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Localized</a:t>
                      </a:r>
                      <a:r>
                        <a:rPr lang="en-US" sz="1200" baseline="0" dirty="0" smtClean="0">
                          <a:latin typeface="Times New Roman" pitchFamily="18" charset="0"/>
                          <a:cs typeface="Times New Roman" pitchFamily="18" charset="0"/>
                        </a:rPr>
                        <a:t> 28 (54%)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Metastatic 24 (46%)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</a:tr>
              <a:tr h="640080">
                <a:tc>
                  <a:txBody>
                    <a:bodyPr/>
                    <a:lstStyle/>
                    <a:p>
                      <a:pPr algn="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Age of Tissue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Mean 8.4 years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Median 7 years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Range 3-18 years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/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5242560" y="498902"/>
            <a:ext cx="144780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 smtClean="0"/>
              <a:t>Patel et al</a:t>
            </a:r>
          </a:p>
          <a:p>
            <a:r>
              <a:rPr lang="en-US" sz="1050" dirty="0" smtClean="0"/>
              <a:t>Supplemental Table S1</a:t>
            </a:r>
            <a:endParaRPr lang="en-US" sz="105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55</Words>
  <Application>Microsoft Office PowerPoint</Application>
  <PresentationFormat>On-screen Show (4:3)</PresentationFormat>
  <Paragraphs>1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orinssc</dc:creator>
  <cp:lastModifiedBy>borinssc</cp:lastModifiedBy>
  <cp:revision>3</cp:revision>
  <dcterms:created xsi:type="dcterms:W3CDTF">2012-01-30T20:05:23Z</dcterms:created>
  <dcterms:modified xsi:type="dcterms:W3CDTF">2012-03-18T12:58:03Z</dcterms:modified>
</cp:coreProperties>
</file>